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8CBBC"/>
    <a:srgbClr val="FFFEAF"/>
    <a:srgbClr val="D0CFD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68" d="100"/>
          <a:sy n="68" d="100"/>
        </p:scale>
        <p:origin x="-171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44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2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07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313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053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977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773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500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059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944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261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796C6B-0196-2342-A1C7-1B66BF6434A3}" type="datetimeFigureOut">
              <a:rPr lang="en-US" smtClean="0"/>
              <a:t>2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80EA2-312D-0143-BC95-36DF759CD0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572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ign_contirbution_ai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30" r="13582" b="24815"/>
          <a:stretch/>
        </p:blipFill>
        <p:spPr>
          <a:xfrm>
            <a:off x="6952445" y="548120"/>
            <a:ext cx="2159000" cy="203699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395671" y="17878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7012328" y="2585119"/>
            <a:ext cx="1919681" cy="6644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 rot="5400000">
            <a:off x="6706690" y="2883397"/>
            <a:ext cx="1023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CCB010387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 rot="5400000">
            <a:off x="7115996" y="2883397"/>
            <a:ext cx="1023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CCB050227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 rot="5400000">
            <a:off x="7516551" y="2883397"/>
            <a:ext cx="1023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CCB050354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 rot="5400000">
            <a:off x="7907876" y="2883397"/>
            <a:ext cx="1031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OSU39662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 rot="5400000">
            <a:off x="8314271" y="2883397"/>
            <a:ext cx="1031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OSU431895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81" name="Group 80"/>
          <p:cNvGrpSpPr/>
          <p:nvPr/>
        </p:nvGrpSpPr>
        <p:grpSpPr>
          <a:xfrm>
            <a:off x="21561" y="178788"/>
            <a:ext cx="6023089" cy="6271426"/>
            <a:chOff x="-48999" y="178788"/>
            <a:chExt cx="6023089" cy="6271426"/>
          </a:xfrm>
        </p:grpSpPr>
        <p:sp>
          <p:nvSpPr>
            <p:cNvPr id="6" name="TextBox 5"/>
            <p:cNvSpPr txBox="1"/>
            <p:nvPr/>
          </p:nvSpPr>
          <p:spPr>
            <a:xfrm>
              <a:off x="-31761" y="17878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A</a:t>
              </a:r>
              <a:endParaRPr lang="en-US" b="1" dirty="0">
                <a:latin typeface="Arial"/>
                <a:cs typeface="Arial"/>
              </a:endParaRP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116416" y="548121"/>
              <a:ext cx="5857674" cy="5857674"/>
              <a:chOff x="116416" y="548121"/>
              <a:chExt cx="5857674" cy="5857674"/>
            </a:xfrm>
          </p:grpSpPr>
          <p:pic>
            <p:nvPicPr>
              <p:cNvPr id="5" name="Picture 4" descr="signature_sample_ai.pdf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6416" y="548121"/>
                <a:ext cx="5857674" cy="5857674"/>
              </a:xfrm>
              <a:prstGeom prst="rect">
                <a:avLst/>
              </a:prstGeom>
            </p:spPr>
          </p:pic>
          <p:sp>
            <p:nvSpPr>
              <p:cNvPr id="2" name="TextBox 1"/>
              <p:cNvSpPr txBox="1"/>
              <p:nvPr/>
            </p:nvSpPr>
            <p:spPr>
              <a:xfrm rot="5400000">
                <a:off x="5315780" y="1203850"/>
                <a:ext cx="98733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CCB010387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5400000">
                <a:off x="5312080" y="2258290"/>
                <a:ext cx="98733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CCB050227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5400000">
                <a:off x="5310596" y="3312727"/>
                <a:ext cx="98733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CCB050354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5400000">
                <a:off x="5313328" y="4361231"/>
                <a:ext cx="98733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OSU396622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5400000">
                <a:off x="5309948" y="5409157"/>
                <a:ext cx="98733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OSU431895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62402" y="619731"/>
                <a:ext cx="80445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C&gt;A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431978" y="619731"/>
                <a:ext cx="80445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C&gt;G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299653" y="619731"/>
                <a:ext cx="80445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C&gt;T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166445" y="619731"/>
                <a:ext cx="80445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T&gt;A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036021" y="618019"/>
                <a:ext cx="80445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T&gt;C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903706" y="619731"/>
                <a:ext cx="804457" cy="200055"/>
              </a:xfrm>
              <a:prstGeom prst="rect">
                <a:avLst/>
              </a:prstGeom>
              <a:solidFill>
                <a:srgbClr val="D0CFD0"/>
              </a:solidFill>
              <a:ln w="3175" cmpd="sng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00" dirty="0" smtClean="0">
                    <a:latin typeface="Arial"/>
                    <a:cs typeface="Arial"/>
                  </a:rPr>
                  <a:t>T&gt;G</a:t>
                </a:r>
                <a:endParaRPr lang="en-US" sz="13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49" name="Group 48"/>
            <p:cNvGrpSpPr/>
            <p:nvPr/>
          </p:nvGrpSpPr>
          <p:grpSpPr>
            <a:xfrm>
              <a:off x="148816" y="3933445"/>
              <a:ext cx="449199" cy="1080996"/>
              <a:chOff x="163763" y="3933445"/>
              <a:chExt cx="449199" cy="1080996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298001" y="3967346"/>
                <a:ext cx="231580" cy="9873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6" name="TextBox 35"/>
              <p:cNvSpPr txBox="1">
                <a:spLocks/>
              </p:cNvSpPr>
              <p:nvPr/>
            </p:nvSpPr>
            <p:spPr>
              <a:xfrm>
                <a:off x="163763" y="4148682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37" name="TextBox 36"/>
              <p:cNvSpPr txBox="1">
                <a:spLocks/>
              </p:cNvSpPr>
              <p:nvPr/>
            </p:nvSpPr>
            <p:spPr>
              <a:xfrm>
                <a:off x="168743" y="4376810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38" name="TextBox 37"/>
              <p:cNvSpPr txBox="1">
                <a:spLocks/>
              </p:cNvSpPr>
              <p:nvPr/>
            </p:nvSpPr>
            <p:spPr>
              <a:xfrm>
                <a:off x="173723" y="4594319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39" name="TextBox 38"/>
              <p:cNvSpPr txBox="1">
                <a:spLocks/>
              </p:cNvSpPr>
              <p:nvPr/>
            </p:nvSpPr>
            <p:spPr>
              <a:xfrm>
                <a:off x="178703" y="4819516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40" name="TextBox 39"/>
              <p:cNvSpPr txBox="1">
                <a:spLocks/>
              </p:cNvSpPr>
              <p:nvPr/>
            </p:nvSpPr>
            <p:spPr>
              <a:xfrm>
                <a:off x="168743" y="3933445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2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148816" y="4975404"/>
              <a:ext cx="449199" cy="1080996"/>
              <a:chOff x="163763" y="3933445"/>
              <a:chExt cx="449199" cy="1080996"/>
            </a:xfrm>
          </p:grpSpPr>
          <p:sp>
            <p:nvSpPr>
              <p:cNvPr id="51" name="Rectangle 50"/>
              <p:cNvSpPr/>
              <p:nvPr/>
            </p:nvSpPr>
            <p:spPr>
              <a:xfrm>
                <a:off x="298001" y="3967346"/>
                <a:ext cx="231580" cy="9873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2" name="TextBox 51"/>
              <p:cNvSpPr txBox="1">
                <a:spLocks/>
              </p:cNvSpPr>
              <p:nvPr/>
            </p:nvSpPr>
            <p:spPr>
              <a:xfrm>
                <a:off x="163763" y="4148682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3" name="TextBox 52"/>
              <p:cNvSpPr txBox="1">
                <a:spLocks/>
              </p:cNvSpPr>
              <p:nvPr/>
            </p:nvSpPr>
            <p:spPr>
              <a:xfrm>
                <a:off x="168743" y="4376810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4" name="TextBox 53"/>
              <p:cNvSpPr txBox="1">
                <a:spLocks/>
              </p:cNvSpPr>
              <p:nvPr/>
            </p:nvSpPr>
            <p:spPr>
              <a:xfrm>
                <a:off x="173723" y="4594319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5" name="TextBox 54"/>
              <p:cNvSpPr txBox="1">
                <a:spLocks/>
              </p:cNvSpPr>
              <p:nvPr/>
            </p:nvSpPr>
            <p:spPr>
              <a:xfrm>
                <a:off x="178703" y="4819516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56" name="TextBox 55"/>
              <p:cNvSpPr txBox="1">
                <a:spLocks/>
              </p:cNvSpPr>
              <p:nvPr/>
            </p:nvSpPr>
            <p:spPr>
              <a:xfrm>
                <a:off x="168743" y="3933445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2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64" name="Group 63"/>
            <p:cNvGrpSpPr/>
            <p:nvPr/>
          </p:nvGrpSpPr>
          <p:grpSpPr>
            <a:xfrm>
              <a:off x="148816" y="1837214"/>
              <a:ext cx="449199" cy="1080996"/>
              <a:chOff x="163763" y="3933445"/>
              <a:chExt cx="449199" cy="1080996"/>
            </a:xfrm>
          </p:grpSpPr>
          <p:sp>
            <p:nvSpPr>
              <p:cNvPr id="65" name="Rectangle 64"/>
              <p:cNvSpPr/>
              <p:nvPr/>
            </p:nvSpPr>
            <p:spPr>
              <a:xfrm>
                <a:off x="298001" y="3967346"/>
                <a:ext cx="231580" cy="9873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6" name="TextBox 65"/>
              <p:cNvSpPr txBox="1">
                <a:spLocks/>
              </p:cNvSpPr>
              <p:nvPr/>
            </p:nvSpPr>
            <p:spPr>
              <a:xfrm>
                <a:off x="163763" y="4148682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7" name="TextBox 66"/>
              <p:cNvSpPr txBox="1">
                <a:spLocks/>
              </p:cNvSpPr>
              <p:nvPr/>
            </p:nvSpPr>
            <p:spPr>
              <a:xfrm>
                <a:off x="168743" y="4376810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8" name="TextBox 67"/>
              <p:cNvSpPr txBox="1">
                <a:spLocks/>
              </p:cNvSpPr>
              <p:nvPr/>
            </p:nvSpPr>
            <p:spPr>
              <a:xfrm>
                <a:off x="173723" y="4594319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9" name="TextBox 68"/>
              <p:cNvSpPr txBox="1">
                <a:spLocks/>
              </p:cNvSpPr>
              <p:nvPr/>
            </p:nvSpPr>
            <p:spPr>
              <a:xfrm>
                <a:off x="178703" y="4819516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70" name="TextBox 69"/>
              <p:cNvSpPr txBox="1">
                <a:spLocks/>
              </p:cNvSpPr>
              <p:nvPr/>
            </p:nvSpPr>
            <p:spPr>
              <a:xfrm>
                <a:off x="168743" y="3933445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2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78" name="Rectangle 77"/>
            <p:cNvSpPr/>
            <p:nvPr/>
          </p:nvSpPr>
          <p:spPr>
            <a:xfrm>
              <a:off x="172557" y="3058156"/>
              <a:ext cx="106144" cy="74790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grpSp>
          <p:nvGrpSpPr>
            <p:cNvPr id="71" name="Group 70"/>
            <p:cNvGrpSpPr/>
            <p:nvPr/>
          </p:nvGrpSpPr>
          <p:grpSpPr>
            <a:xfrm>
              <a:off x="148816" y="784185"/>
              <a:ext cx="449199" cy="1080996"/>
              <a:chOff x="163763" y="3933445"/>
              <a:chExt cx="449199" cy="1080996"/>
            </a:xfrm>
          </p:grpSpPr>
          <p:sp>
            <p:nvSpPr>
              <p:cNvPr id="72" name="Rectangle 71"/>
              <p:cNvSpPr/>
              <p:nvPr/>
            </p:nvSpPr>
            <p:spPr>
              <a:xfrm>
                <a:off x="298001" y="3967346"/>
                <a:ext cx="231580" cy="9873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3" name="TextBox 72"/>
              <p:cNvSpPr txBox="1">
                <a:spLocks/>
              </p:cNvSpPr>
              <p:nvPr/>
            </p:nvSpPr>
            <p:spPr>
              <a:xfrm>
                <a:off x="163763" y="4148682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74" name="TextBox 73"/>
              <p:cNvSpPr txBox="1">
                <a:spLocks/>
              </p:cNvSpPr>
              <p:nvPr/>
            </p:nvSpPr>
            <p:spPr>
              <a:xfrm>
                <a:off x="168743" y="4376810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75" name="TextBox 74"/>
              <p:cNvSpPr txBox="1">
                <a:spLocks/>
              </p:cNvSpPr>
              <p:nvPr/>
            </p:nvSpPr>
            <p:spPr>
              <a:xfrm>
                <a:off x="173723" y="4594319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76" name="TextBox 75"/>
              <p:cNvSpPr txBox="1">
                <a:spLocks/>
              </p:cNvSpPr>
              <p:nvPr/>
            </p:nvSpPr>
            <p:spPr>
              <a:xfrm>
                <a:off x="178703" y="4819516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77" name="TextBox 76"/>
              <p:cNvSpPr txBox="1">
                <a:spLocks/>
              </p:cNvSpPr>
              <p:nvPr/>
            </p:nvSpPr>
            <p:spPr>
              <a:xfrm>
                <a:off x="168743" y="3933445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2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57" name="Group 56"/>
            <p:cNvGrpSpPr/>
            <p:nvPr/>
          </p:nvGrpSpPr>
          <p:grpSpPr>
            <a:xfrm>
              <a:off x="148816" y="2883867"/>
              <a:ext cx="449199" cy="1074677"/>
              <a:chOff x="163763" y="3939764"/>
              <a:chExt cx="449199" cy="1074677"/>
            </a:xfrm>
          </p:grpSpPr>
          <p:sp>
            <p:nvSpPr>
              <p:cNvPr id="58" name="Rectangle 57"/>
              <p:cNvSpPr/>
              <p:nvPr/>
            </p:nvSpPr>
            <p:spPr>
              <a:xfrm>
                <a:off x="298001" y="3967346"/>
                <a:ext cx="231580" cy="9873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9" name="TextBox 58"/>
              <p:cNvSpPr txBox="1">
                <a:spLocks/>
              </p:cNvSpPr>
              <p:nvPr/>
            </p:nvSpPr>
            <p:spPr>
              <a:xfrm>
                <a:off x="163763" y="4148682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0" name="TextBox 59"/>
              <p:cNvSpPr txBox="1">
                <a:spLocks/>
              </p:cNvSpPr>
              <p:nvPr/>
            </p:nvSpPr>
            <p:spPr>
              <a:xfrm>
                <a:off x="168743" y="4376810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1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1" name="TextBox 60"/>
              <p:cNvSpPr txBox="1">
                <a:spLocks/>
              </p:cNvSpPr>
              <p:nvPr/>
            </p:nvSpPr>
            <p:spPr>
              <a:xfrm>
                <a:off x="173723" y="4594319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5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2" name="TextBox 61"/>
              <p:cNvSpPr txBox="1">
                <a:spLocks/>
              </p:cNvSpPr>
              <p:nvPr/>
            </p:nvSpPr>
            <p:spPr>
              <a:xfrm>
                <a:off x="178703" y="4819516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0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3" name="TextBox 62"/>
              <p:cNvSpPr txBox="1">
                <a:spLocks/>
              </p:cNvSpPr>
              <p:nvPr/>
            </p:nvSpPr>
            <p:spPr>
              <a:xfrm>
                <a:off x="168743" y="3939764"/>
                <a:ext cx="434259" cy="1949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60000"/>
                  </a:lnSpc>
                </a:pPr>
                <a:r>
                  <a:rPr lang="en-US" sz="1000" dirty="0" smtClean="0">
                    <a:latin typeface="Arial"/>
                    <a:cs typeface="Arial"/>
                  </a:rPr>
                  <a:t>0.20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79" name="TextBox 78"/>
            <p:cNvSpPr txBox="1"/>
            <p:nvPr/>
          </p:nvSpPr>
          <p:spPr>
            <a:xfrm rot="16200000">
              <a:off x="-417722" y="2962192"/>
              <a:ext cx="10144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Contribution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900837" y="6173215"/>
              <a:ext cx="531215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Motif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sp>
        <p:nvSpPr>
          <p:cNvPr id="85" name="TextBox 84"/>
          <p:cNvSpPr txBox="1"/>
          <p:nvPr/>
        </p:nvSpPr>
        <p:spPr>
          <a:xfrm rot="16200000">
            <a:off x="5933907" y="1526531"/>
            <a:ext cx="1587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Percent Contribution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9085787" y="410486"/>
            <a:ext cx="45719" cy="2174633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extBox 85"/>
          <p:cNvSpPr txBox="1"/>
          <p:nvPr/>
        </p:nvSpPr>
        <p:spPr>
          <a:xfrm>
            <a:off x="6790069" y="235984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760889" y="19447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5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761540" y="1461544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5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6760889" y="101210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75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6691580" y="563196"/>
            <a:ext cx="273541" cy="21544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7311932" y="3633191"/>
            <a:ext cx="1638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</a:t>
            </a:r>
            <a:r>
              <a:rPr lang="en-US" sz="1200" dirty="0" smtClean="0">
                <a:latin typeface="Arial"/>
                <a:cs typeface="Arial"/>
              </a:rPr>
              <a:t>ignature COSMIC-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7311932" y="3842619"/>
            <a:ext cx="1736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</a:t>
            </a:r>
            <a:r>
              <a:rPr lang="en-US" sz="1200" dirty="0" smtClean="0">
                <a:latin typeface="Arial"/>
                <a:cs typeface="Arial"/>
              </a:rPr>
              <a:t>ignature COSMIC-1A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7232585" y="3718284"/>
            <a:ext cx="127289" cy="124987"/>
          </a:xfrm>
          <a:prstGeom prst="rect">
            <a:avLst/>
          </a:prstGeom>
          <a:solidFill>
            <a:srgbClr val="78CBBC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/>
          <p:cNvSpPr/>
          <p:nvPr/>
        </p:nvSpPr>
        <p:spPr>
          <a:xfrm>
            <a:off x="7245261" y="3925256"/>
            <a:ext cx="127289" cy="124987"/>
          </a:xfrm>
          <a:prstGeom prst="rect">
            <a:avLst/>
          </a:prstGeom>
          <a:solidFill>
            <a:srgbClr val="FFFEA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383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72</Words>
  <Application>Microsoft Macintosh PowerPoint</Application>
  <PresentationFormat>On-screen Show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file</dc:creator>
  <cp:lastModifiedBy>profile</cp:lastModifiedBy>
  <cp:revision>12</cp:revision>
  <dcterms:created xsi:type="dcterms:W3CDTF">2018-09-19T16:19:35Z</dcterms:created>
  <dcterms:modified xsi:type="dcterms:W3CDTF">2019-02-13T07:15:38Z</dcterms:modified>
</cp:coreProperties>
</file>